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5DBF4F-9195-4CE3-B30F-710DB840C04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E70720-A532-41F8-A6C3-051759C756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EA5638-69E1-4042-B289-DA134480209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2860F7-4E46-491C-B369-514DCDFCF84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1B3626-1745-4073-823E-A35EBD02C0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D45632-A554-4A2B-B578-8787FC9072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57045F-12D5-4B71-9A46-19525D56BE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37A2E0-D4E9-4036-961C-FD44999BC2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8F9D1D-282D-4D97-91B0-842A9BBA0C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C6F223-86EB-40B8-A415-917108BADA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AC2059-142E-43D7-B8CE-F6CBF9956D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CF48B7-2036-40CD-A636-0F6804D67F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0A355D9-46BE-47E7-8AFD-6AB3FB286D8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hyperlink" Target="http://www.nature.com/nature/" TargetMode="Externa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slideLayout" Target="../slideLayouts/slideLayout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 flipH="1">
            <a:off x="457200" y="1600200"/>
            <a:ext cx="1744560" cy="71424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31320" rIns="31320" tIns="31320" bIns="3132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ndara"/>
                <a:ea typeface="Arial"/>
              </a:rPr>
              <a:t>Knowledge Modeling from Peer-Reviewed Literatu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ndara"/>
                <a:ea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Candara"/>
                <a:ea typeface="Arial"/>
              </a:rPr>
              <a:t>(e.g. activity of A </a:t>
            </a:r>
            <a:r>
              <a:rPr b="0" lang="en-US" sz="1000" spc="-1" strike="noStrike">
                <a:solidFill>
                  <a:srgbClr val="000000"/>
                </a:solidFill>
                <a:latin typeface="Wingdings 3"/>
                <a:ea typeface="Wingdings 3"/>
              </a:rPr>
              <a:t></a:t>
            </a:r>
            <a:r>
              <a:rPr b="0" lang="en-US" sz="1000" spc="-1" strike="noStrike">
                <a:solidFill>
                  <a:srgbClr val="000000"/>
                </a:solidFill>
                <a:latin typeface="Candara"/>
                <a:ea typeface="Arial"/>
              </a:rPr>
              <a:t> expression of B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Nature 15 April 2004">
            <a:hlinkClick r:id="rId1"/>
          </p:cNvPr>
          <p:cNvPicPr/>
          <p:nvPr/>
        </p:nvPicPr>
        <p:blipFill>
          <a:blip r:embed="rId2"/>
          <a:stretch/>
        </p:blipFill>
        <p:spPr>
          <a:xfrm>
            <a:off x="2036880" y="1965240"/>
            <a:ext cx="303120" cy="35892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tretch/>
        </p:blipFill>
        <p:spPr>
          <a:xfrm>
            <a:off x="363600" y="1963800"/>
            <a:ext cx="276120" cy="35712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541440" y="2455920"/>
            <a:ext cx="1538280" cy="1811160"/>
          </a:xfrm>
          <a:prstGeom prst="can">
            <a:avLst>
              <a:gd name="adj" fmla="val 25000"/>
            </a:avLst>
          </a:prstGeom>
          <a:gradFill rotWithShape="0">
            <a:gsLst>
              <a:gs pos="0">
                <a:srgbClr val="002f2f"/>
              </a:gs>
              <a:gs pos="50000">
                <a:srgbClr val="006666"/>
              </a:gs>
              <a:gs pos="100000">
                <a:srgbClr val="002f2f"/>
              </a:gs>
            </a:gsLst>
            <a:lin ang="108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3600" rIns="93600" tIns="46800" bIns="46800" anchor="ctr" anchorCtr="1">
            <a:noAutofit/>
          </a:bodyPr>
          <a:p>
            <a:pPr algn="ctr">
              <a:tabLst>
                <a:tab algn="l" pos="0"/>
                <a:tab algn="l" pos="934920"/>
                <a:tab algn="l" pos="1870200"/>
                <a:tab algn="l" pos="2805120"/>
                <a:tab algn="l" pos="3740040"/>
                <a:tab algn="l" pos="4675320"/>
                <a:tab algn="l" pos="5610240"/>
                <a:tab algn="l" pos="6545160"/>
                <a:tab algn="l" pos="7480440"/>
                <a:tab algn="l" pos="8415360"/>
                <a:tab algn="l" pos="9350280"/>
                <a:tab algn="l" pos="102855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rot="5400000">
            <a:off x="1095480" y="2434320"/>
            <a:ext cx="447840" cy="230040"/>
          </a:xfrm>
          <a:custGeom>
            <a:avLst/>
            <a:gdLst>
              <a:gd name="textAreaLeft" fmla="*/ 69840 w 447840"/>
              <a:gd name="textAreaRight" fmla="*/ 342000 w 447840"/>
              <a:gd name="textAreaTop" fmla="*/ 55800 h 230040"/>
              <a:gd name="textAreaBottom" fmla="*/ 174240 h 230040"/>
            </a:gdLst>
            <a:ahLst/>
            <a:rect l="textAreaLeft" t="textAreaTop" r="textAreaRight" b="textAreaBottom"/>
            <a:pathLst>
              <a:path w="21600" h="21600">
                <a:moveTo>
                  <a:pt x="3375" y="5250"/>
                </a:moveTo>
                <a:lnTo>
                  <a:pt x="11671" y="5250"/>
                </a:lnTo>
                <a:lnTo>
                  <a:pt x="11671" y="0"/>
                </a:lnTo>
                <a:lnTo>
                  <a:pt x="21600" y="10800"/>
                </a:lnTo>
                <a:lnTo>
                  <a:pt x="11671" y="21600"/>
                </a:lnTo>
                <a:lnTo>
                  <a:pt x="11671" y="16350"/>
                </a:lnTo>
                <a:lnTo>
                  <a:pt x="3375" y="16350"/>
                </a:lnTo>
                <a:close/>
              </a:path>
              <a:path w="21600" h="21600">
                <a:moveTo>
                  <a:pt x="0" y="5250"/>
                </a:moveTo>
                <a:lnTo>
                  <a:pt x="675" y="5250"/>
                </a:lnTo>
                <a:lnTo>
                  <a:pt x="675" y="16350"/>
                </a:lnTo>
                <a:lnTo>
                  <a:pt x="0" y="16350"/>
                </a:lnTo>
                <a:close/>
              </a:path>
              <a:path w="21600" h="21600">
                <a:moveTo>
                  <a:pt x="1350" y="5250"/>
                </a:moveTo>
                <a:lnTo>
                  <a:pt x="2700" y="5250"/>
                </a:lnTo>
                <a:lnTo>
                  <a:pt x="2700" y="16350"/>
                </a:lnTo>
                <a:lnTo>
                  <a:pt x="1350" y="16350"/>
                </a:lnTo>
                <a:close/>
              </a:path>
            </a:pathLst>
          </a:custGeom>
          <a:gradFill rotWithShape="0">
            <a:gsLst>
              <a:gs pos="0">
                <a:srgbClr val="0033cc"/>
              </a:gs>
              <a:gs pos="100000">
                <a:srgbClr val="00175e"/>
              </a:gs>
            </a:gsLst>
            <a:lin ang="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619360" y="2460600"/>
            <a:ext cx="1376280" cy="1806480"/>
          </a:xfrm>
          <a:prstGeom prst="can">
            <a:avLst>
              <a:gd name="adj" fmla="val 25000"/>
            </a:avLst>
          </a:prstGeom>
          <a:gradFill rotWithShape="0">
            <a:gsLst>
              <a:gs pos="0">
                <a:srgbClr val="46172f"/>
              </a:gs>
              <a:gs pos="50000">
                <a:srgbClr val="993366"/>
              </a:gs>
              <a:gs pos="100000">
                <a:srgbClr val="46172f"/>
              </a:gs>
            </a:gsLst>
            <a:lin ang="108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3600" rIns="93600" tIns="46800" bIns="46800" anchor="ctr" anchorCtr="1">
            <a:noAutofit/>
          </a:bodyPr>
          <a:p>
            <a:pPr algn="ctr">
              <a:tabLst>
                <a:tab algn="l" pos="0"/>
                <a:tab algn="l" pos="934920"/>
                <a:tab algn="l" pos="1870200"/>
                <a:tab algn="l" pos="2805120"/>
                <a:tab algn="l" pos="3740040"/>
                <a:tab algn="l" pos="4675320"/>
                <a:tab algn="l" pos="5610240"/>
                <a:tab algn="l" pos="6545160"/>
                <a:tab algn="l" pos="7480440"/>
                <a:tab algn="l" pos="8415360"/>
                <a:tab algn="l" pos="9350280"/>
                <a:tab algn="l" pos="102855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133720" y="3352680"/>
            <a:ext cx="469800" cy="228600"/>
          </a:xfrm>
          <a:custGeom>
            <a:avLst/>
            <a:gdLst>
              <a:gd name="textAreaLeft" fmla="*/ 73440 w 469800"/>
              <a:gd name="textAreaRight" fmla="*/ 358920 w 469800"/>
              <a:gd name="textAreaTop" fmla="*/ 55440 h 228600"/>
              <a:gd name="textAreaBottom" fmla="*/ 173160 h 228600"/>
            </a:gdLst>
            <a:ahLst/>
            <a:rect l="textAreaLeft" t="textAreaTop" r="textAreaRight" b="textAreaBottom"/>
            <a:pathLst>
              <a:path w="21600" h="21600">
                <a:moveTo>
                  <a:pt x="3375" y="5250"/>
                </a:moveTo>
                <a:lnTo>
                  <a:pt x="11671" y="5250"/>
                </a:lnTo>
                <a:lnTo>
                  <a:pt x="11671" y="0"/>
                </a:lnTo>
                <a:lnTo>
                  <a:pt x="21600" y="10800"/>
                </a:lnTo>
                <a:lnTo>
                  <a:pt x="11671" y="21600"/>
                </a:lnTo>
                <a:lnTo>
                  <a:pt x="11671" y="16350"/>
                </a:lnTo>
                <a:lnTo>
                  <a:pt x="3375" y="16350"/>
                </a:lnTo>
                <a:close/>
              </a:path>
              <a:path w="21600" h="21600">
                <a:moveTo>
                  <a:pt x="0" y="5250"/>
                </a:moveTo>
                <a:lnTo>
                  <a:pt x="675" y="5250"/>
                </a:lnTo>
                <a:lnTo>
                  <a:pt x="675" y="16350"/>
                </a:lnTo>
                <a:lnTo>
                  <a:pt x="0" y="16350"/>
                </a:lnTo>
                <a:close/>
              </a:path>
              <a:path w="21600" h="21600">
                <a:moveTo>
                  <a:pt x="1350" y="5250"/>
                </a:moveTo>
                <a:lnTo>
                  <a:pt x="2700" y="5250"/>
                </a:lnTo>
                <a:lnTo>
                  <a:pt x="2700" y="16350"/>
                </a:lnTo>
                <a:lnTo>
                  <a:pt x="1350" y="16350"/>
                </a:lnTo>
                <a:close/>
              </a:path>
            </a:pathLst>
          </a:custGeom>
          <a:gradFill rotWithShape="0">
            <a:gsLst>
              <a:gs pos="0">
                <a:srgbClr val="00175e"/>
              </a:gs>
              <a:gs pos="100000">
                <a:srgbClr val="0033cc"/>
              </a:gs>
            </a:gsLst>
            <a:lin ang="108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57200" y="3124080"/>
            <a:ext cx="1751040" cy="715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600" rIns="93600" tIns="46800" bIns="46800" anchor="t">
            <a:spAutoFit/>
          </a:bodyPr>
          <a:p>
            <a:pPr algn="ctr">
              <a:lnSpc>
                <a:spcPct val="80000"/>
              </a:lnSpc>
              <a:spcBef>
                <a:spcPts val="300"/>
              </a:spcBef>
              <a:tabLst>
                <a:tab algn="l" pos="0"/>
                <a:tab algn="l" pos="934920"/>
                <a:tab algn="l" pos="1870200"/>
                <a:tab algn="l" pos="2805120"/>
                <a:tab algn="l" pos="3740040"/>
                <a:tab algn="l" pos="4675320"/>
                <a:tab algn="l" pos="5610240"/>
                <a:tab algn="l" pos="6545160"/>
                <a:tab algn="l" pos="7480440"/>
                <a:tab algn="l" pos="8415360"/>
                <a:tab algn="l" pos="9350280"/>
                <a:tab algn="l" pos="10285560"/>
              </a:tabLst>
            </a:pPr>
            <a:r>
              <a:rPr b="1" lang="en-US" sz="1200" spc="-1" strike="noStrike">
                <a:solidFill>
                  <a:srgbClr val="eaeaea"/>
                </a:solidFill>
                <a:latin typeface="Candara"/>
              </a:rPr>
              <a:t>Knowledgeba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80000"/>
              </a:lnSpc>
              <a:spcBef>
                <a:spcPts val="300"/>
              </a:spcBef>
              <a:tabLst>
                <a:tab algn="l" pos="0"/>
                <a:tab algn="l" pos="934920"/>
                <a:tab algn="l" pos="1870200"/>
                <a:tab algn="l" pos="2805120"/>
                <a:tab algn="l" pos="3740040"/>
                <a:tab algn="l" pos="4675320"/>
                <a:tab algn="l" pos="5610240"/>
                <a:tab algn="l" pos="6545160"/>
                <a:tab algn="l" pos="7480440"/>
                <a:tab algn="l" pos="8415360"/>
                <a:tab algn="l" pos="9350280"/>
                <a:tab algn="l" pos="10285560"/>
              </a:tabLst>
            </a:pPr>
            <a:r>
              <a:rPr b="0" lang="en-US" sz="1200" spc="-1" strike="noStrike">
                <a:solidFill>
                  <a:srgbClr val="eaeaea"/>
                </a:solidFill>
                <a:latin typeface="Candara"/>
              </a:rPr>
              <a:t>Collection of cause and effect biological relationship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619360" y="2860560"/>
            <a:ext cx="1371600" cy="119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600" rIns="93600" tIns="46800" bIns="46800" anchor="t">
            <a:spAutoFit/>
          </a:bodyPr>
          <a:p>
            <a:pPr algn="ctr">
              <a:lnSpc>
                <a:spcPct val="80000"/>
              </a:lnSpc>
              <a:spcBef>
                <a:spcPts val="300"/>
              </a:spcBef>
              <a:tabLst>
                <a:tab algn="l" pos="0"/>
                <a:tab algn="l" pos="934920"/>
                <a:tab algn="l" pos="1870200"/>
                <a:tab algn="l" pos="2805120"/>
                <a:tab algn="l" pos="3740040"/>
                <a:tab algn="l" pos="4675320"/>
                <a:tab algn="l" pos="5610240"/>
                <a:tab algn="l" pos="6545160"/>
                <a:tab algn="l" pos="7480440"/>
                <a:tab algn="l" pos="8415360"/>
                <a:tab algn="l" pos="9350280"/>
                <a:tab algn="l" pos="10285560"/>
              </a:tabLst>
            </a:pPr>
            <a:r>
              <a:rPr b="1" lang="en-US" sz="1200" spc="-1" strike="noStrike">
                <a:solidFill>
                  <a:srgbClr val="eaeaea"/>
                </a:solidFill>
                <a:latin typeface="Candara"/>
              </a:rPr>
              <a:t>Knowledge Assembly Model (KA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80000"/>
              </a:lnSpc>
              <a:spcBef>
                <a:spcPts val="300"/>
              </a:spcBef>
              <a:tabLst>
                <a:tab algn="l" pos="0"/>
                <a:tab algn="l" pos="934920"/>
                <a:tab algn="l" pos="1870200"/>
                <a:tab algn="l" pos="2805120"/>
                <a:tab algn="l" pos="3740040"/>
                <a:tab algn="l" pos="4675320"/>
                <a:tab algn="l" pos="5610240"/>
                <a:tab algn="l" pos="6545160"/>
                <a:tab algn="l" pos="7480440"/>
                <a:tab algn="l" pos="8415360"/>
                <a:tab algn="l" pos="9350280"/>
                <a:tab algn="l" pos="10285560"/>
              </a:tabLst>
            </a:pPr>
            <a:r>
              <a:rPr b="0" lang="en-US" sz="1200" spc="-1" strike="noStrike">
                <a:solidFill>
                  <a:srgbClr val="eaeaea"/>
                </a:solidFill>
                <a:latin typeface="Candara"/>
              </a:rPr>
              <a:t>Context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80000"/>
              </a:lnSpc>
              <a:spcBef>
                <a:spcPts val="300"/>
              </a:spcBef>
              <a:tabLst>
                <a:tab algn="l" pos="0"/>
                <a:tab algn="l" pos="934920"/>
                <a:tab algn="l" pos="1870200"/>
                <a:tab algn="l" pos="2805120"/>
                <a:tab algn="l" pos="3740040"/>
                <a:tab algn="l" pos="4675320"/>
                <a:tab algn="l" pos="5610240"/>
                <a:tab algn="l" pos="6545160"/>
                <a:tab algn="l" pos="7480440"/>
                <a:tab algn="l" pos="8415360"/>
                <a:tab algn="l" pos="9350280"/>
                <a:tab algn="l" pos="10285560"/>
              </a:tabLst>
            </a:pPr>
            <a:r>
              <a:rPr b="0" lang="en-US" sz="1200" spc="-1" strike="noStrike">
                <a:solidFill>
                  <a:srgbClr val="eaeaea"/>
                </a:solidFill>
                <a:latin typeface="Candara"/>
              </a:rPr>
              <a:t>specific KAMs from the Knowledgeba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962520" y="2514600"/>
            <a:ext cx="1081080" cy="914400"/>
          </a:xfrm>
          <a:custGeom>
            <a:avLst/>
            <a:gdLst/>
            <a:ahLst/>
            <a:rect l="l" t="t" r="r" b="b"/>
            <a:pathLst>
              <a:path w="1170" h="755">
                <a:moveTo>
                  <a:pt x="0" y="657"/>
                </a:moveTo>
                <a:cubicBezTo>
                  <a:pt x="192" y="706"/>
                  <a:pt x="385" y="755"/>
                  <a:pt x="492" y="657"/>
                </a:cubicBezTo>
                <a:cubicBezTo>
                  <a:pt x="599" y="559"/>
                  <a:pt x="529" y="134"/>
                  <a:pt x="642" y="67"/>
                </a:cubicBezTo>
                <a:cubicBezTo>
                  <a:pt x="755" y="0"/>
                  <a:pt x="962" y="128"/>
                  <a:pt x="1170" y="256"/>
                </a:cubicBezTo>
              </a:path>
            </a:pathLst>
          </a:custGeom>
          <a:noFill/>
          <a:ln w="57240">
            <a:solidFill>
              <a:srgbClr val="993366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890960" y="2133720"/>
            <a:ext cx="604800" cy="641160"/>
          </a:xfrm>
          <a:custGeom>
            <a:avLst/>
            <a:gdLst/>
            <a:ahLst/>
            <a:rect l="l" t="t" r="r" b="b"/>
            <a:pathLst>
              <a:path w="702" h="701">
                <a:moveTo>
                  <a:pt x="702" y="6"/>
                </a:moveTo>
                <a:cubicBezTo>
                  <a:pt x="608" y="3"/>
                  <a:pt x="515" y="0"/>
                  <a:pt x="439" y="6"/>
                </a:cubicBezTo>
                <a:cubicBezTo>
                  <a:pt x="363" y="12"/>
                  <a:pt x="303" y="12"/>
                  <a:pt x="245" y="41"/>
                </a:cubicBezTo>
                <a:cubicBezTo>
                  <a:pt x="187" y="70"/>
                  <a:pt x="125" y="126"/>
                  <a:pt x="91" y="182"/>
                </a:cubicBezTo>
                <a:cubicBezTo>
                  <a:pt x="57" y="238"/>
                  <a:pt x="0" y="294"/>
                  <a:pt x="39" y="380"/>
                </a:cubicBezTo>
                <a:cubicBezTo>
                  <a:pt x="78" y="466"/>
                  <a:pt x="201" y="583"/>
                  <a:pt x="324" y="701"/>
                </a:cubicBezTo>
              </a:path>
            </a:pathLst>
          </a:custGeom>
          <a:noFill/>
          <a:ln w="57240">
            <a:solidFill>
              <a:srgbClr val="80808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flipH="1">
            <a:off x="5454000" y="1905120"/>
            <a:ext cx="3268440" cy="777600"/>
          </a:xfrm>
          <a:prstGeom prst="roundRect">
            <a:avLst>
              <a:gd name="adj" fmla="val 16667"/>
            </a:avLst>
          </a:prstGeom>
          <a:gradFill rotWithShape="0">
            <a:gsLst>
              <a:gs pos="0">
                <a:srgbClr val="bdbdbd"/>
              </a:gs>
              <a:gs pos="50000">
                <a:srgbClr val="dddddd"/>
              </a:gs>
              <a:gs pos="100000">
                <a:srgbClr val="bdbdbd"/>
              </a:gs>
            </a:gsLst>
            <a:lin ang="108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31320" rIns="31320" tIns="31320" bIns="3132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ndara"/>
              </a:rPr>
              <a:t>Data Input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ndara"/>
                <a:ea typeface="Arial"/>
              </a:rPr>
              <a:t>Statistically significant expression changes from multiple ‘omic data typ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4572000" y="2862360"/>
            <a:ext cx="4160880" cy="315756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prstDash val="dashDot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flipH="1">
            <a:off x="4723560" y="2895480"/>
            <a:ext cx="3946680" cy="1219320"/>
          </a:xfrm>
          <a:prstGeom prst="roundRect">
            <a:avLst>
              <a:gd name="adj" fmla="val 16667"/>
            </a:avLst>
          </a:prstGeom>
          <a:gradFill rotWithShape="0">
            <a:gsLst>
              <a:gs pos="0">
                <a:srgbClr val="739ac1"/>
              </a:gs>
              <a:gs pos="50000">
                <a:srgbClr val="99ccff"/>
              </a:gs>
              <a:gs pos="100000">
                <a:srgbClr val="739ac1"/>
              </a:gs>
            </a:gsLst>
            <a:lin ang="10800000"/>
          </a:gra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31320" rIns="31320" tIns="31320" bIns="31320" anchor="t">
            <a:noAutofit/>
          </a:bodyPr>
          <a:p>
            <a:pPr algn="ctr">
              <a:tabLst>
                <a:tab algn="l" pos="0"/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7107120" y="3008160"/>
            <a:ext cx="1427400" cy="954360"/>
          </a:xfrm>
          <a:prstGeom prst="rect">
            <a:avLst/>
          </a:prstGeom>
          <a:solidFill>
            <a:srgbClr val="ffffff"/>
          </a:solidFill>
          <a:ln w="12600">
            <a:solidFill>
              <a:srgbClr val="a5002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" descr=""/>
          <p:cNvPicPr/>
          <p:nvPr/>
        </p:nvPicPr>
        <p:blipFill>
          <a:blip r:embed="rId4"/>
          <a:stretch/>
        </p:blipFill>
        <p:spPr>
          <a:xfrm>
            <a:off x="7315200" y="3276720"/>
            <a:ext cx="966960" cy="628560"/>
          </a:xfrm>
          <a:prstGeom prst="rect">
            <a:avLst/>
          </a:prstGeom>
          <a:ln w="0">
            <a:noFill/>
          </a:ln>
        </p:spPr>
      </p:pic>
      <p:sp>
        <p:nvSpPr>
          <p:cNvPr id="57" name=""/>
          <p:cNvSpPr/>
          <p:nvPr/>
        </p:nvSpPr>
        <p:spPr>
          <a:xfrm>
            <a:off x="4740120" y="3011400"/>
            <a:ext cx="2295720" cy="105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600" rIns="93600" tIns="46800" bIns="46800" anchor="t">
            <a:spAutoFit/>
          </a:bodyPr>
          <a:p>
            <a:pPr algn="ctr">
              <a:lnSpc>
                <a:spcPct val="80000"/>
              </a:lnSpc>
              <a:spcBef>
                <a:spcPts val="349"/>
              </a:spcBef>
              <a:tabLst>
                <a:tab algn="l" pos="0"/>
                <a:tab algn="l" pos="934920"/>
                <a:tab algn="l" pos="1870200"/>
                <a:tab algn="l" pos="2805120"/>
                <a:tab algn="l" pos="3740040"/>
                <a:tab algn="l" pos="4675320"/>
                <a:tab algn="l" pos="5610240"/>
                <a:tab algn="l" pos="6545160"/>
                <a:tab algn="l" pos="7480440"/>
                <a:tab algn="l" pos="8415360"/>
                <a:tab algn="l" pos="9350280"/>
                <a:tab algn="l" pos="102855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ndara"/>
              </a:rPr>
              <a:t>Reverse Causal Reasoni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80000"/>
              </a:lnSpc>
              <a:spcBef>
                <a:spcPts val="300"/>
              </a:spcBef>
              <a:tabLst>
                <a:tab algn="l" pos="0"/>
                <a:tab algn="l" pos="934920"/>
                <a:tab algn="l" pos="1870200"/>
                <a:tab algn="l" pos="2805120"/>
                <a:tab algn="l" pos="3740040"/>
                <a:tab algn="l" pos="4675320"/>
                <a:tab algn="l" pos="5610240"/>
                <a:tab algn="l" pos="6545160"/>
                <a:tab algn="l" pos="7480440"/>
                <a:tab algn="l" pos="8415360"/>
                <a:tab algn="l" pos="9350280"/>
                <a:tab algn="l" pos="102855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ndara"/>
              </a:rPr>
              <a:t>Use of inference engine to identify the most probable upstream biological explanations as hypothes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flipH="1">
            <a:off x="7009560" y="3046320"/>
            <a:ext cx="1568520" cy="238320"/>
          </a:xfrm>
          <a:prstGeom prst="roundRect">
            <a:avLst>
              <a:gd name="adj" fmla="val 16667"/>
            </a:avLst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1320" rIns="31320" tIns="31320" bIns="3132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ndara"/>
                <a:ea typeface="Arial"/>
              </a:rPr>
              <a:t>Hypothes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4648320" y="4724280"/>
            <a:ext cx="4017960" cy="1206720"/>
          </a:xfrm>
          <a:prstGeom prst="roundRect">
            <a:avLst>
              <a:gd name="adj" fmla="val 16667"/>
            </a:avLst>
          </a:prstGeom>
          <a:gradFill rotWithShape="0">
            <a:gsLst>
              <a:gs pos="0">
                <a:srgbClr val="171746"/>
              </a:gs>
              <a:gs pos="50000">
                <a:srgbClr val="333399"/>
              </a:gs>
              <a:gs pos="100000">
                <a:srgbClr val="171746"/>
              </a:gs>
            </a:gsLst>
            <a:lin ang="108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3600" rIns="93600" tIns="46800" bIns="46800" anchor="t" anchorCtr="1">
            <a:noAutofit/>
          </a:bodyPr>
          <a:p>
            <a:pPr algn="ctr">
              <a:tabLst>
                <a:tab algn="l" pos="0"/>
                <a:tab algn="l" pos="934920"/>
                <a:tab algn="l" pos="1870200"/>
                <a:tab algn="l" pos="2805120"/>
                <a:tab algn="l" pos="3740040"/>
                <a:tab algn="l" pos="4675320"/>
                <a:tab algn="l" pos="5610240"/>
                <a:tab algn="l" pos="6545160"/>
                <a:tab algn="l" pos="7480440"/>
                <a:tab algn="l" pos="8415360"/>
                <a:tab algn="l" pos="9350280"/>
                <a:tab algn="l" pos="102855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rot="5400000">
            <a:off x="6432480" y="4311720"/>
            <a:ext cx="457200" cy="216000"/>
          </a:xfrm>
          <a:custGeom>
            <a:avLst/>
            <a:gdLst>
              <a:gd name="textAreaLeft" fmla="*/ 71280 w 457200"/>
              <a:gd name="textAreaRight" fmla="*/ 349200 w 457200"/>
              <a:gd name="textAreaTop" fmla="*/ 52560 h 216000"/>
              <a:gd name="textAreaBottom" fmla="*/ 163440 h 216000"/>
            </a:gdLst>
            <a:ahLst/>
            <a:rect l="textAreaLeft" t="textAreaTop" r="textAreaRight" b="textAreaBottom"/>
            <a:pathLst>
              <a:path w="21600" h="21600">
                <a:moveTo>
                  <a:pt x="3375" y="5250"/>
                </a:moveTo>
                <a:lnTo>
                  <a:pt x="11671" y="5250"/>
                </a:lnTo>
                <a:lnTo>
                  <a:pt x="11671" y="0"/>
                </a:lnTo>
                <a:lnTo>
                  <a:pt x="21600" y="10800"/>
                </a:lnTo>
                <a:lnTo>
                  <a:pt x="11671" y="21600"/>
                </a:lnTo>
                <a:lnTo>
                  <a:pt x="11671" y="16350"/>
                </a:lnTo>
                <a:lnTo>
                  <a:pt x="3375" y="16350"/>
                </a:lnTo>
                <a:close/>
              </a:path>
              <a:path w="21600" h="21600">
                <a:moveTo>
                  <a:pt x="0" y="5250"/>
                </a:moveTo>
                <a:lnTo>
                  <a:pt x="675" y="5250"/>
                </a:lnTo>
                <a:lnTo>
                  <a:pt x="675" y="16350"/>
                </a:lnTo>
                <a:lnTo>
                  <a:pt x="0" y="16350"/>
                </a:lnTo>
                <a:close/>
              </a:path>
              <a:path w="21600" h="21600">
                <a:moveTo>
                  <a:pt x="1350" y="5250"/>
                </a:moveTo>
                <a:lnTo>
                  <a:pt x="2700" y="5250"/>
                </a:lnTo>
                <a:lnTo>
                  <a:pt x="2700" y="16350"/>
                </a:lnTo>
                <a:lnTo>
                  <a:pt x="1350" y="16350"/>
                </a:lnTo>
                <a:close/>
              </a:path>
            </a:pathLst>
          </a:custGeom>
          <a:gradFill rotWithShape="0">
            <a:gsLst>
              <a:gs pos="0">
                <a:srgbClr val="00175e"/>
              </a:gs>
              <a:gs pos="100000">
                <a:srgbClr val="0033cc"/>
              </a:gs>
            </a:gsLst>
            <a:lin ang="54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" descr=""/>
          <p:cNvPicPr/>
          <p:nvPr/>
        </p:nvPicPr>
        <p:blipFill>
          <a:blip r:embed="rId5"/>
          <a:stretch/>
        </p:blipFill>
        <p:spPr>
          <a:xfrm>
            <a:off x="7086600" y="4876920"/>
            <a:ext cx="1442880" cy="938160"/>
          </a:xfrm>
          <a:prstGeom prst="rect">
            <a:avLst/>
          </a:prstGeom>
          <a:ln w="12600">
            <a:solidFill>
              <a:srgbClr val="a50021"/>
            </a:solidFill>
            <a:miter/>
          </a:ln>
        </p:spPr>
      </p:pic>
      <p:sp>
        <p:nvSpPr>
          <p:cNvPr id="62" name=""/>
          <p:cNvSpPr/>
          <p:nvPr/>
        </p:nvSpPr>
        <p:spPr>
          <a:xfrm>
            <a:off x="4632480" y="4849920"/>
            <a:ext cx="2368440" cy="1250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600" rIns="936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34920"/>
                <a:tab algn="l" pos="1870200"/>
                <a:tab algn="l" pos="2805120"/>
                <a:tab algn="l" pos="3740040"/>
                <a:tab algn="l" pos="4675320"/>
                <a:tab algn="l" pos="5610240"/>
                <a:tab algn="l" pos="6545160"/>
                <a:tab algn="l" pos="7480440"/>
                <a:tab algn="l" pos="8415360"/>
                <a:tab algn="l" pos="9350280"/>
                <a:tab algn="l" pos="10285560"/>
              </a:tabLst>
            </a:pPr>
            <a:r>
              <a:rPr b="1" lang="en-US" sz="1400" spc="-1" strike="noStrike">
                <a:solidFill>
                  <a:srgbClr val="ffffcc"/>
                </a:solidFill>
                <a:latin typeface="Candara"/>
              </a:rPr>
              <a:t>Causal Network Modeli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34920"/>
                <a:tab algn="l" pos="1870200"/>
                <a:tab algn="l" pos="2805120"/>
                <a:tab algn="l" pos="3740040"/>
                <a:tab algn="l" pos="4675320"/>
                <a:tab algn="l" pos="5610240"/>
                <a:tab algn="l" pos="6545160"/>
                <a:tab algn="l" pos="7480440"/>
                <a:tab algn="l" pos="8415360"/>
                <a:tab algn="l" pos="9350280"/>
                <a:tab algn="l" pos="10285560"/>
              </a:tabLst>
            </a:pPr>
            <a:r>
              <a:rPr b="0" lang="en-US" sz="1200" spc="-1" strike="noStrike">
                <a:solidFill>
                  <a:srgbClr val="ffffcc"/>
                </a:solidFill>
                <a:latin typeface="Candara"/>
              </a:rPr>
              <a:t>Expert biologists refine and reconstruct hypotheses into comprehensive biological network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0" y="-360"/>
            <a:ext cx="9144000" cy="1219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333399"/>
                </a:solidFill>
                <a:latin typeface="Arial"/>
              </a:rPr>
              <a:t>Figure S5: Summary Overview of Causal Reasoning Methodology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6-14T14:01:23Z</dcterms:created>
  <dc:creator>Sean Eddy</dc:creator>
  <dc:description/>
  <dc:language>en-US</dc:language>
  <cp:lastModifiedBy>mmacoritto</cp:lastModifiedBy>
  <dcterms:modified xsi:type="dcterms:W3CDTF">2010-06-22T16:28:16Z</dcterms:modified>
  <cp:revision>4</cp:revision>
  <dc:subject/>
  <dc:title>Genstruct’s Modeling Methodology</dc:title>
</cp:coreProperties>
</file>